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52605E-F305-475D-A877-B5942363BE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69A5728-1FFA-4A7A-9C12-22B4568BDD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204C61B-EE12-48DC-99C5-250342D7A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2EE538-7990-4320-97AF-F51C98A80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635CB4-C805-497B-8B3C-4C0776BA9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1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6A30B0-B5DA-47BA-BAC6-697D69D98A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2D55CEB-EFD8-4261-8425-7510845B29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2BEBBF4-73BF-4F57-9C6D-49134C081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409F6D-2F8C-4DB2-8682-148F657BA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8883242-3CCB-424F-9064-469E2136F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905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3E3BA8C-794C-438C-92BB-F41BADD14F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2D1FE11-D2AB-4A92-93D1-F09FC52A70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3CE5278-C0E7-47E3-8D68-59562595F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54E7CE3-AA4E-4AAB-85DD-9F4C1757D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C5CC5EE-54A3-4141-8B52-4875EBA99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42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F7A57D-15DC-4E84-890B-19C19D1D22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53130A-395C-4339-8352-48FEE045C5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0A0DBC-F977-4D99-9AC8-768447358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A38A430-3719-4C90-8D41-9BF40526F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BB9663A-A478-4E07-8D95-35202776D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148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8C7E76-7CE8-424D-A2A7-B1BEFBD857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A03B5B5-8027-473C-BA4E-EDEFE99728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AD85F11-0270-4BE3-AFAF-A138A50049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1A20E7-35F1-4BBD-8314-E80EE0B35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33C475-FC26-4FA6-A86F-D0971960A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109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BA2366-6F2A-42E1-A795-C35887401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9B285C8-4868-4D58-973C-794BBC39DA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A903FFB-94C1-4CB8-9BB4-4E984E55C2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044BF92-11AB-4D96-9C1A-6A29DFA04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C647390-C655-411B-81E0-C19259275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7F5042B-6176-45E7-A24D-DA86C71A7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94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18C121-12CE-428B-A433-A523A25CAD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3BCDFFE-C771-4E63-9C6B-F69C225DE0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C2DDABA-6220-43DD-81BB-CF4308A165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E24F169-3E9B-41FE-A3E7-D504DEB10F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1622D09-1C0D-45A9-8779-6CB72CD232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490505E-43EC-4D87-A87B-F1FBB5965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E55B438-0ACD-4B90-BB03-2B05FEBAB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CE8C5D5-47D2-47D8-9B3C-1862C48B7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53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FB213BD-3AD2-4C78-9F0C-806A6C1E2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B326265-2183-429C-AB3A-8B6E98FC3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4125D5D2-A3E3-4FC6-94FC-0EC4FB33A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698AAB4-D7C5-4D38-9F11-7CE51F380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795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FEA3621-5764-4B8A-B553-6D7E02B3A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D1D792A-75B7-45FB-A1EF-6D35A2222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E877839-CE2A-40A4-8E4C-FE722B109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428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8D1237-CE47-4935-A960-95469FF2B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906C502-570C-4E26-B564-0CC814C2C6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05F051E-583A-4524-9A07-6AA8187FE2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7B221F-D0BF-402E-890B-9C691AB2E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281E576-FFD2-4A2B-9388-FDEE50368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099D359-8913-4D70-8A07-996853B41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29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62D364-E8E9-4556-949C-CB08508E3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4D81426-E2F5-4B81-BB11-2F8FE9B28C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8993B60-F413-4549-BF31-8EAC0DE00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8D08FF-0DCB-43EC-9875-BD58EB774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B19489A-0856-4D36-BE55-B1618BD54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0D9310-9394-4126-B1E9-111C63A69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917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65E34B6-85A9-4051-96E8-5E9ED2364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9EE5E97-246F-493D-8F69-3BFAC2331A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927BC7-5785-434D-B30E-07FB197AFD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E9F2B-C715-49CD-9031-177247E27D1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81E785B-905D-4E01-B3AD-E15C887AD2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2B4F84-752F-4D61-8412-4F99366230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464DF-EA99-45FD-B775-802FA6C2A67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924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AABA5E6-A5EA-4224-BCA6-F08D8CAF85DB}"/>
              </a:ext>
            </a:extLst>
          </p:cNvPr>
          <p:cNvSpPr txBox="1"/>
          <p:nvPr/>
        </p:nvSpPr>
        <p:spPr>
          <a:xfrm>
            <a:off x="732711" y="96892"/>
            <a:ext cx="1002833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: A) h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tma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orrelations between microbial taxa at family level (≥25% prevalence over all samples) and the ARGs (minimum prevalence level of 25%). B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) Principal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Analysis (PCA) and C) Two-Way Partial Least Squares (O2PLS) analyses  of microbial taxa at family level (≥25% prevalence over all samples) and the ARGs (minimum prevalence level of 25%). O2PLS loadings of  D) Families and E) ARGs. 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0167D31-3FCF-42B5-958D-665DD0E20A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26" t="25325" b="9486"/>
          <a:stretch/>
        </p:blipFill>
        <p:spPr>
          <a:xfrm>
            <a:off x="3285074" y="1396273"/>
            <a:ext cx="8068726" cy="4710112"/>
          </a:xfrm>
          <a:prstGeom prst="rect">
            <a:avLst/>
          </a:prstGeom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id="{580E2D06-FF9C-43F5-A024-D626D1A746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0504" b="74953"/>
          <a:stretch/>
        </p:blipFill>
        <p:spPr>
          <a:xfrm>
            <a:off x="1019902" y="4206975"/>
            <a:ext cx="2447435" cy="1503231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90FA4B75-2860-499B-9323-8D8725F9B5F8}"/>
              </a:ext>
            </a:extLst>
          </p:cNvPr>
          <p:cNvSpPr txBox="1"/>
          <p:nvPr/>
        </p:nvSpPr>
        <p:spPr>
          <a:xfrm>
            <a:off x="732711" y="1289963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306188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90FA4B75-2860-499B-9323-8D8725F9B5F8}"/>
              </a:ext>
            </a:extLst>
          </p:cNvPr>
          <p:cNvSpPr txBox="1"/>
          <p:nvPr/>
        </p:nvSpPr>
        <p:spPr>
          <a:xfrm>
            <a:off x="741419" y="166557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8" name="Picture 9">
            <a:extLst>
              <a:ext uri="{FF2B5EF4-FFF2-40B4-BE49-F238E27FC236}">
                <a16:creationId xmlns:a16="http://schemas.microsoft.com/office/drawing/2014/main" id="{0CBA75FA-2ECB-4269-805E-E518573605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7862" y="474334"/>
            <a:ext cx="8296275" cy="600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028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90FA4B75-2860-499B-9323-8D8725F9B5F8}"/>
              </a:ext>
            </a:extLst>
          </p:cNvPr>
          <p:cNvSpPr txBox="1"/>
          <p:nvPr/>
        </p:nvSpPr>
        <p:spPr>
          <a:xfrm>
            <a:off x="741419" y="166557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3" name="Picture 10">
            <a:extLst>
              <a:ext uri="{FF2B5EF4-FFF2-40B4-BE49-F238E27FC236}">
                <a16:creationId xmlns:a16="http://schemas.microsoft.com/office/drawing/2014/main" id="{60CC0C42-9E98-4619-B02D-C1114FC375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7862" y="474334"/>
            <a:ext cx="8296275" cy="600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8406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90FA4B75-2860-499B-9323-8D8725F9B5F8}"/>
              </a:ext>
            </a:extLst>
          </p:cNvPr>
          <p:cNvSpPr txBox="1"/>
          <p:nvPr/>
        </p:nvSpPr>
        <p:spPr>
          <a:xfrm>
            <a:off x="741419" y="166557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pic>
        <p:nvPicPr>
          <p:cNvPr id="3" name="Content Placeholder 4">
            <a:extLst>
              <a:ext uri="{FF2B5EF4-FFF2-40B4-BE49-F238E27FC236}">
                <a16:creationId xmlns:a16="http://schemas.microsoft.com/office/drawing/2014/main" id="{4CD65556-C218-4CCF-A98B-0B41D20A82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1735" y="1253331"/>
            <a:ext cx="5868530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943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90FA4B75-2860-499B-9323-8D8725F9B5F8}"/>
              </a:ext>
            </a:extLst>
          </p:cNvPr>
          <p:cNvSpPr txBox="1"/>
          <p:nvPr/>
        </p:nvSpPr>
        <p:spPr>
          <a:xfrm>
            <a:off x="741419" y="166557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pic>
        <p:nvPicPr>
          <p:cNvPr id="3" name="Content Placeholder 5">
            <a:extLst>
              <a:ext uri="{FF2B5EF4-FFF2-40B4-BE49-F238E27FC236}">
                <a16:creationId xmlns:a16="http://schemas.microsoft.com/office/drawing/2014/main" id="{2907D0A8-8CC1-4343-AB31-4B2948D1EF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161735" y="1253331"/>
            <a:ext cx="5868530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674803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</TotalTime>
  <Words>94</Words>
  <Application>Microsoft Office PowerPoint</Application>
  <PresentationFormat>Widescreen</PresentationFormat>
  <Paragraphs>6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7</cp:revision>
  <dcterms:created xsi:type="dcterms:W3CDTF">2024-07-02T09:49:38Z</dcterms:created>
  <dcterms:modified xsi:type="dcterms:W3CDTF">2024-08-21T10:06:03Z</dcterms:modified>
</cp:coreProperties>
</file>